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xlsx" ContentType="application/vnd.openxmlformats-officedocument.spreadsheetml.sheet"/>
  <Override PartName="/ppt/embeddings/oleObject7.xlsx" ContentType="application/vnd.openxmlformats-officedocument.spreadsheetml.sheet"/>
  <Override PartName="/ppt/embeddings/oleObject2.xlsx" ContentType="application/vnd.openxmlformats-officedocument.spreadsheetml.sheet"/>
  <Override PartName="/ppt/embeddings/oleObject8.xlsx" ContentType="application/vnd.openxmlformats-officedocument.spreadsheetml.sheet"/>
  <Override PartName="/ppt/embeddings/oleObject3.xlsx" ContentType="application/vnd.openxmlformats-officedocument.spreadsheetml.sheet"/>
  <Override PartName="/ppt/embeddings/oleObject4.xlsx" ContentType="application/vnd.openxmlformats-officedocument.spreadsheetml.sheet"/>
  <Override PartName="/ppt/embeddings/oleObject5.xlsx" ContentType="application/vnd.openxmlformats-officedocument.spreadsheetml.sheet"/>
  <Override PartName="/ppt/embeddings/oleObject6.xlsx" ContentType="application/vnd.openxmlformats-officedocument.spreadsheetml.sheet"/>
  <Override PartName="/ppt/media/image1.pct" ContentType="image/x-pict"/>
  <Override PartName="/ppt/media/image2.pct" ContentType="image/x-pict"/>
  <Override PartName="/ppt/media/image3.pct" ContentType="image/x-pict"/>
  <Override PartName="/ppt/media/image4.pct" ContentType="image/x-pict"/>
  <Override PartName="/ppt/media/image5.pct" ContentType="image/x-pict"/>
  <Override PartName="/ppt/media/image6.pct" ContentType="image/x-pict"/>
  <Override PartName="/ppt/media/image7.pct" ContentType="image/x-pict"/>
  <Override PartName="/ppt/media/image8.pct" ContentType="image/x-pict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CF2E359-390D-47DA-A3E4-4371FC27B1E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3168E6-7AF9-489E-9E8F-4CDD7184CAC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CD347E-7DE8-4033-80EA-48013DAF0CA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64168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507640"/>
            <a:ext cx="187668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C8C51F-21FE-47A2-9733-37F3DB9AA56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B5FD9F-FFD9-491C-A314-99B8BB264F0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9D9EB2-4554-41E6-8F8C-A24F317B044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BB900-C63D-49B9-BA60-4A784699A3A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81BDC6-AAAA-4419-996D-EB03C7C5041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12520"/>
            <a:ext cx="582912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E8A28-EE71-47E7-8143-AD322DD9C8A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1DAF5-46EB-4EBD-9A59-5E568ECECA4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50764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E966BA-9258-4AFB-9AE2-5DD109AB175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641680"/>
            <a:ext cx="284436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507640"/>
            <a:ext cx="5829120" cy="2616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391475-6899-461F-81A8-2706E88FCF8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12520"/>
            <a:ext cx="582912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641680"/>
            <a:ext cx="5829120" cy="5486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8331120"/>
            <a:ext cx="142884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31120"/>
            <a:ext cx="217152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8331120"/>
            <a:ext cx="1428480" cy="609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6D22A5D-9F4F-4080-9152-908AD8E5B928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package" Target="../embeddings/oleObject1.xlsx"/><Relationship Id="rId2" Type="http://schemas.openxmlformats.org/officeDocument/2006/relationships/image" Target="../media/image1.pct"/><Relationship Id="rId3" Type="http://schemas.openxmlformats.org/officeDocument/2006/relationships/package" Target="../embeddings/oleObject2.xlsx"/><Relationship Id="rId4" Type="http://schemas.openxmlformats.org/officeDocument/2006/relationships/image" Target="../media/image2.pct"/><Relationship Id="rId5" Type="http://schemas.openxmlformats.org/officeDocument/2006/relationships/package" Target="../embeddings/oleObject3.xlsx"/><Relationship Id="rId6" Type="http://schemas.openxmlformats.org/officeDocument/2006/relationships/image" Target="../media/image3.pct"/><Relationship Id="rId7" Type="http://schemas.openxmlformats.org/officeDocument/2006/relationships/package" Target="../embeddings/oleObject4.xlsx"/><Relationship Id="rId8" Type="http://schemas.openxmlformats.org/officeDocument/2006/relationships/image" Target="../media/image4.pct"/><Relationship Id="rId9" Type="http://schemas.openxmlformats.org/officeDocument/2006/relationships/package" Target="../embeddings/oleObject5.xlsx"/><Relationship Id="rId10" Type="http://schemas.openxmlformats.org/officeDocument/2006/relationships/image" Target="../media/image5.pct"/><Relationship Id="rId11" Type="http://schemas.openxmlformats.org/officeDocument/2006/relationships/package" Target="../embeddings/oleObject6.xlsx"/><Relationship Id="rId12" Type="http://schemas.openxmlformats.org/officeDocument/2006/relationships/image" Target="../media/image6.pct"/><Relationship Id="rId13" Type="http://schemas.openxmlformats.org/officeDocument/2006/relationships/package" Target="../embeddings/oleObject7.xlsx"/><Relationship Id="rId14" Type="http://schemas.openxmlformats.org/officeDocument/2006/relationships/image" Target="../media/image7.pct"/><Relationship Id="rId15" Type="http://schemas.openxmlformats.org/officeDocument/2006/relationships/package" Target="../embeddings/oleObject8.xlsx"/><Relationship Id="rId16" Type="http://schemas.openxmlformats.org/officeDocument/2006/relationships/image" Target="../media/image8.pct"/><Relationship Id="rId1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17360" y="127080"/>
            <a:ext cx="6624720" cy="8941320"/>
            <a:chOff x="117360" y="127080"/>
            <a:chExt cx="6624720" cy="8941320"/>
          </a:xfrm>
        </p:grpSpPr>
        <p:graphicFrame>
          <p:nvGraphicFramePr>
            <p:cNvPr id="42" name=""/>
            <p:cNvGraphicFramePr/>
            <p:nvPr/>
          </p:nvGraphicFramePr>
          <p:xfrm>
            <a:off x="3487680" y="2682720"/>
            <a:ext cx="3254400" cy="1627200"/>
          </p:xfrm>
          <a:graphic>
            <a:graphicData uri="http://schemas.openxmlformats.org/presentationml/2006/ole">
              <p:oleObj progId="Excel.Sheet.12" r:id="rId1" spid="">
                <p:embed/>
                <p:pic>
                  <p:nvPicPr>
                    <p:cNvPr id="43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3487680" y="2682720"/>
                      <a:ext cx="3254400" cy="162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4" name=""/>
            <p:cNvGraphicFramePr/>
            <p:nvPr/>
          </p:nvGraphicFramePr>
          <p:xfrm>
            <a:off x="117360" y="4838760"/>
            <a:ext cx="3254400" cy="1627200"/>
          </p:xfrm>
          <a:graphic>
            <a:graphicData uri="http://schemas.openxmlformats.org/presentationml/2006/ole">
              <p:oleObj progId="Excel.Sheet.12" r:id="rId3" spid="">
                <p:embed/>
                <p:pic>
                  <p:nvPicPr>
                    <p:cNvPr id="45" name="" descr="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117360" y="4838760"/>
                      <a:ext cx="3254400" cy="162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6" name=""/>
            <p:cNvGraphicFramePr/>
            <p:nvPr/>
          </p:nvGraphicFramePr>
          <p:xfrm>
            <a:off x="117360" y="2682720"/>
            <a:ext cx="3254400" cy="1625760"/>
          </p:xfrm>
          <a:graphic>
            <a:graphicData uri="http://schemas.openxmlformats.org/presentationml/2006/ole">
              <p:oleObj progId="Excel.Sheet.12" r:id="rId5" spid="">
                <p:embed/>
                <p:pic>
                  <p:nvPicPr>
                    <p:cNvPr id="47" name="" descr="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117360" y="2682720"/>
                      <a:ext cx="3254400" cy="16257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48" name=""/>
            <p:cNvGraphicFramePr/>
            <p:nvPr/>
          </p:nvGraphicFramePr>
          <p:xfrm>
            <a:off x="117360" y="528480"/>
            <a:ext cx="3252960" cy="1624320"/>
          </p:xfrm>
          <a:graphic>
            <a:graphicData uri="http://schemas.openxmlformats.org/presentationml/2006/ole">
              <p:oleObj progId="Excel.Sheet.12" r:id="rId7" spid="">
                <p:embed/>
                <p:pic>
                  <p:nvPicPr>
                    <p:cNvPr id="49" name="" descr=""/>
                    <p:cNvPicPr/>
                    <p:nvPr/>
                  </p:nvPicPr>
                  <p:blipFill>
                    <a:blip r:embed="rId8"/>
                    <a:stretch/>
                  </p:blipFill>
                  <p:spPr>
                    <a:xfrm>
                      <a:off x="117360" y="528480"/>
                      <a:ext cx="3252960" cy="1624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0" name=""/>
            <p:cNvGraphicFramePr/>
            <p:nvPr/>
          </p:nvGraphicFramePr>
          <p:xfrm>
            <a:off x="3487680" y="528480"/>
            <a:ext cx="3252960" cy="1624320"/>
          </p:xfrm>
          <a:graphic>
            <a:graphicData uri="http://schemas.openxmlformats.org/presentationml/2006/ole">
              <p:oleObj progId="Excel.Sheet.12" r:id="rId9" spid="">
                <p:embed/>
                <p:pic>
                  <p:nvPicPr>
                    <p:cNvPr id="51" name="" descr=""/>
                    <p:cNvPicPr/>
                    <p:nvPr/>
                  </p:nvPicPr>
                  <p:blipFill>
                    <a:blip r:embed="rId10"/>
                    <a:stretch/>
                  </p:blipFill>
                  <p:spPr>
                    <a:xfrm>
                      <a:off x="3487680" y="528480"/>
                      <a:ext cx="3252960" cy="162432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2" name=""/>
            <p:cNvGraphicFramePr/>
            <p:nvPr/>
          </p:nvGraphicFramePr>
          <p:xfrm>
            <a:off x="3487680" y="4838760"/>
            <a:ext cx="3252960" cy="1623960"/>
          </p:xfrm>
          <a:graphic>
            <a:graphicData uri="http://schemas.openxmlformats.org/presentationml/2006/ole">
              <p:oleObj progId="Excel.Sheet.12" r:id="rId11" spid="">
                <p:embed/>
                <p:pic>
                  <p:nvPicPr>
                    <p:cNvPr id="53" name="" descr=""/>
                    <p:cNvPicPr/>
                    <p:nvPr/>
                  </p:nvPicPr>
                  <p:blipFill>
                    <a:blip r:embed="rId12"/>
                    <a:stretch/>
                  </p:blipFill>
                  <p:spPr>
                    <a:xfrm>
                      <a:off x="3487680" y="4838760"/>
                      <a:ext cx="3252960" cy="162396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4" name=""/>
            <p:cNvGraphicFramePr/>
            <p:nvPr/>
          </p:nvGraphicFramePr>
          <p:xfrm>
            <a:off x="117360" y="6993000"/>
            <a:ext cx="3254400" cy="1627200"/>
          </p:xfrm>
          <a:graphic>
            <a:graphicData uri="http://schemas.openxmlformats.org/presentationml/2006/ole">
              <p:oleObj progId="Excel.Sheet.12" r:id="rId13" spid="">
                <p:embed/>
                <p:pic>
                  <p:nvPicPr>
                    <p:cNvPr id="55" name="" descr=""/>
                    <p:cNvPicPr/>
                    <p:nvPr/>
                  </p:nvPicPr>
                  <p:blipFill>
                    <a:blip r:embed="rId14"/>
                    <a:stretch/>
                  </p:blipFill>
                  <p:spPr>
                    <a:xfrm>
                      <a:off x="117360" y="6993000"/>
                      <a:ext cx="3254400" cy="162720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graphicFrame>
          <p:nvGraphicFramePr>
            <p:cNvPr id="56" name=""/>
            <p:cNvGraphicFramePr/>
            <p:nvPr/>
          </p:nvGraphicFramePr>
          <p:xfrm>
            <a:off x="3483000" y="6985080"/>
            <a:ext cx="3254400" cy="1630440"/>
          </p:xfrm>
          <a:graphic>
            <a:graphicData uri="http://schemas.openxmlformats.org/presentationml/2006/ole">
              <p:oleObj progId="Excel.Sheet.12" r:id="rId15" spid="">
                <p:embed/>
                <p:pic>
                  <p:nvPicPr>
                    <p:cNvPr id="57" name="" descr=""/>
                    <p:cNvPicPr/>
                    <p:nvPr/>
                  </p:nvPicPr>
                  <p:blipFill>
                    <a:blip r:embed="rId16"/>
                    <a:stretch/>
                  </p:blipFill>
                  <p:spPr>
                    <a:xfrm>
                      <a:off x="3483000" y="6985080"/>
                      <a:ext cx="3254400" cy="1630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  <p:sp>
          <p:nvSpPr>
            <p:cNvPr id="58" name=""/>
            <p:cNvSpPr/>
            <p:nvPr/>
          </p:nvSpPr>
          <p:spPr>
            <a:xfrm>
              <a:off x="135000" y="127080"/>
              <a:ext cx="18396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458640" y="8632800"/>
              <a:ext cx="1027080" cy="435600"/>
              <a:chOff x="458640" y="8632800"/>
              <a:chExt cx="1027080" cy="435600"/>
            </a:xfrm>
          </p:grpSpPr>
          <p:grpSp>
            <p:nvGrpSpPr>
              <p:cNvPr id="60" name=""/>
              <p:cNvGrpSpPr/>
              <p:nvPr/>
            </p:nvGrpSpPr>
            <p:grpSpPr>
              <a:xfrm>
                <a:off x="458640" y="8836200"/>
                <a:ext cx="995400" cy="232200"/>
                <a:chOff x="458640" y="8836200"/>
                <a:chExt cx="995400" cy="232200"/>
              </a:xfrm>
            </p:grpSpPr>
            <p:sp>
              <p:nvSpPr>
                <p:cNvPr id="61" name=""/>
                <p:cNvSpPr/>
                <p:nvPr/>
              </p:nvSpPr>
              <p:spPr>
                <a:xfrm>
                  <a:off x="458640" y="8915400"/>
                  <a:ext cx="55800" cy="55440"/>
                </a:xfrm>
                <a:prstGeom prst="rect">
                  <a:avLst/>
                </a:prstGeom>
                <a:solidFill>
                  <a:srgbClr val="fe00fe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8640" bIns="864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2" name=""/>
                <p:cNvSpPr/>
                <p:nvPr/>
              </p:nvSpPr>
              <p:spPr>
                <a:xfrm>
                  <a:off x="500040" y="8836200"/>
                  <a:ext cx="954000" cy="2322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F</a:t>
                  </a:r>
                  <a:r>
                    <a:rPr b="0" lang="en-US" sz="800" spc="-1" strike="noStrike" baseline="-25000">
                      <a:solidFill>
                        <a:srgbClr val="000000"/>
                      </a:solidFill>
                      <a:latin typeface="Times New Roman"/>
                    </a:rPr>
                    <a:t>0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F</a:t>
                  </a:r>
                  <a:r>
                    <a:rPr b="0" lang="en-US" sz="800" spc="-1" strike="noStrike" baseline="-25000">
                      <a:solidFill>
                        <a:srgbClr val="000000"/>
                      </a:solidFill>
                      <a:latin typeface="Times New Roman"/>
                    </a:rPr>
                    <a:t>1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 ATP synthase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  <p:grpSp>
            <p:nvGrpSpPr>
              <p:cNvPr id="63" name=""/>
              <p:cNvGrpSpPr/>
              <p:nvPr/>
            </p:nvGrpSpPr>
            <p:grpSpPr>
              <a:xfrm>
                <a:off x="458640" y="8632800"/>
                <a:ext cx="1027080" cy="215640"/>
                <a:chOff x="458640" y="8632800"/>
                <a:chExt cx="1027080" cy="215640"/>
              </a:xfrm>
            </p:grpSpPr>
            <p:sp>
              <p:nvSpPr>
                <p:cNvPr id="64" name=""/>
                <p:cNvSpPr/>
                <p:nvPr/>
              </p:nvSpPr>
              <p:spPr>
                <a:xfrm>
                  <a:off x="458640" y="8712360"/>
                  <a:ext cx="55800" cy="55440"/>
                </a:xfrm>
                <a:prstGeom prst="rect">
                  <a:avLst/>
                </a:prstGeom>
                <a:solidFill>
                  <a:srgbClr val="04ccfd"/>
                </a:solidFill>
                <a:ln w="648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8640" bIns="8640" anchor="ctr">
                  <a:noAutofit/>
                </a:bodyPr>
                <a:p>
                  <a:endParaRPr b="0" lang="en-US" sz="24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  <p:sp>
              <p:nvSpPr>
                <p:cNvPr id="65" name=""/>
                <p:cNvSpPr/>
                <p:nvPr/>
              </p:nvSpPr>
              <p:spPr>
                <a:xfrm>
                  <a:off x="495720" y="8632800"/>
                  <a:ext cx="990000" cy="21564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i="1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neuABC, cst</a:t>
                  </a:r>
                  <a:r>
                    <a:rPr b="0" lang="en-US" sz="800" spc="-1" strike="noStrike">
                      <a:solidFill>
                        <a:srgbClr val="000000"/>
                      </a:solidFill>
                      <a:latin typeface="Times New Roman"/>
                    </a:rPr>
                    <a:t> cluster</a:t>
                  </a:r>
                  <a:endParaRPr b="0" lang="en-US" sz="800" spc="-1" strike="noStrike">
                    <a:solidFill>
                      <a:srgbClr val="000000"/>
                    </a:solidFill>
                    <a:latin typeface="Times New Roman"/>
                  </a:endParaRPr>
                </a:p>
              </p:txBody>
            </p:sp>
          </p:grpSp>
        </p:grpSp>
        <p:grpSp>
          <p:nvGrpSpPr>
            <p:cNvPr id="66" name=""/>
            <p:cNvGrpSpPr/>
            <p:nvPr/>
          </p:nvGrpSpPr>
          <p:grpSpPr>
            <a:xfrm>
              <a:off x="2023920" y="8632800"/>
              <a:ext cx="860760" cy="419040"/>
              <a:chOff x="2023920" y="8632800"/>
              <a:chExt cx="860760" cy="419040"/>
            </a:xfrm>
          </p:grpSpPr>
          <p:sp>
            <p:nvSpPr>
              <p:cNvPr id="67" name=""/>
              <p:cNvSpPr/>
              <p:nvPr/>
            </p:nvSpPr>
            <p:spPr>
              <a:xfrm>
                <a:off x="2023920" y="8915400"/>
                <a:ext cx="55440" cy="55800"/>
              </a:xfrm>
              <a:prstGeom prst="rect">
                <a:avLst/>
              </a:prstGeom>
              <a:solidFill>
                <a:srgbClr val="fc6704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9000" bIns="90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2063520" y="8836200"/>
                <a:ext cx="61668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translation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>
                <a:off x="2023920" y="8712360"/>
                <a:ext cx="55440" cy="55440"/>
              </a:xfrm>
              <a:prstGeom prst="rect">
                <a:avLst/>
              </a:prstGeom>
              <a:solidFill>
                <a:srgbClr val="d73331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8640" bIns="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2062080" y="8632800"/>
                <a:ext cx="8226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i="1" lang="en-US" sz="800" spc="-1" strike="noStrike">
                    <a:solidFill>
                      <a:srgbClr val="000000"/>
                    </a:solidFill>
                    <a:latin typeface="Times New Roman"/>
                  </a:rPr>
                  <a:t>vacA</a:t>
                </a: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 fragments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71" name=""/>
            <p:cNvGrpSpPr/>
            <p:nvPr/>
          </p:nvGrpSpPr>
          <p:grpSpPr>
            <a:xfrm>
              <a:off x="3425760" y="8632800"/>
              <a:ext cx="721440" cy="418680"/>
              <a:chOff x="3425760" y="8632800"/>
              <a:chExt cx="721440" cy="418680"/>
            </a:xfrm>
          </p:grpSpPr>
          <p:sp>
            <p:nvSpPr>
              <p:cNvPr id="72" name=""/>
              <p:cNvSpPr/>
              <p:nvPr/>
            </p:nvSpPr>
            <p:spPr>
              <a:xfrm>
                <a:off x="3425760" y="8915400"/>
                <a:ext cx="55800" cy="55440"/>
              </a:xfrm>
              <a:prstGeom prst="rect">
                <a:avLst/>
              </a:prstGeom>
              <a:solidFill>
                <a:srgbClr val="ffffff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8640" bIns="864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3466440" y="8835840"/>
                <a:ext cx="68076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R/M system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3425760" y="8712000"/>
                <a:ext cx="55800" cy="55800"/>
              </a:xfrm>
              <a:prstGeom prst="rect">
                <a:avLst/>
              </a:prstGeom>
              <a:solidFill>
                <a:srgbClr val="29b820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9000" bIns="90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3466080" y="8632800"/>
                <a:ext cx="6624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IS elements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grpSp>
          <p:nvGrpSpPr>
            <p:cNvPr id="76" name=""/>
            <p:cNvGrpSpPr/>
            <p:nvPr/>
          </p:nvGrpSpPr>
          <p:grpSpPr>
            <a:xfrm>
              <a:off x="4691160" y="8632800"/>
              <a:ext cx="432000" cy="215640"/>
              <a:chOff x="4691160" y="8632800"/>
              <a:chExt cx="432000" cy="215640"/>
            </a:xfrm>
          </p:grpSpPr>
          <p:sp>
            <p:nvSpPr>
              <p:cNvPr id="77" name=""/>
              <p:cNvSpPr/>
              <p:nvPr/>
            </p:nvSpPr>
            <p:spPr>
              <a:xfrm>
                <a:off x="4691160" y="8712000"/>
                <a:ext cx="55440" cy="55080"/>
              </a:xfrm>
              <a:prstGeom prst="rect">
                <a:avLst/>
              </a:prstGeom>
              <a:solidFill>
                <a:srgbClr val="f6ee17"/>
              </a:solidFill>
              <a:ln w="648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8280" bIns="828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733640" y="8632800"/>
                <a:ext cx="38952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Times New Roman"/>
                  </a:rPr>
                  <a:t>HGT</a:t>
                </a:r>
                <a:endParaRPr b="0" lang="en-US" sz="8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</p:grpSp>
      <p:sp>
        <p:nvSpPr>
          <p:cNvPr id="79" name=""/>
          <p:cNvSpPr/>
          <p:nvPr/>
        </p:nvSpPr>
        <p:spPr>
          <a:xfrm>
            <a:off x="1144440" y="346068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2141640" y="3460680"/>
            <a:ext cx="0" cy="203400"/>
          </a:xfrm>
          <a:prstGeom prst="line">
            <a:avLst/>
          </a:prstGeom>
          <a:ln w="9360">
            <a:solidFill>
              <a:srgbClr val="000000"/>
            </a:solidFill>
            <a:miter/>
            <a:tailEnd len="sm" type="triangle" w="sm"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196920" y="50976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3516120" y="50976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3515040" y="70088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H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3515040" y="2678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196920" y="2678040"/>
            <a:ext cx="26316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196920" y="7008840"/>
            <a:ext cx="26928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G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3520800" y="4862520"/>
            <a:ext cx="25092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F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196920" y="4862520"/>
            <a:ext cx="25704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00" spc="-1" strike="noStrike">
                <a:solidFill>
                  <a:srgbClr val="000000"/>
                </a:solidFill>
                <a:latin typeface="Arial"/>
              </a:rPr>
              <a:t>E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7-20T18:05:53Z</dcterms:created>
  <dc:creator>Claudia Baar</dc:creator>
  <dc:description/>
  <dc:language>en-US</dc:language>
  <cp:lastModifiedBy>Mark Eppinger</cp:lastModifiedBy>
  <cp:lastPrinted>2005-10-20T19:56:58Z</cp:lastPrinted>
  <dcterms:modified xsi:type="dcterms:W3CDTF">2006-06-09T19:00:12Z</dcterms:modified>
  <cp:revision>27</cp:revision>
  <dc:subject/>
  <dc:title>PowerPoint Presentation</dc:title>
</cp:coreProperties>
</file>